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6858000" cy="9906000" type="A4"/>
  <p:notesSz cx="7099300" cy="10234613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Bösken, Björn" initials="BB" lastIdx="57" clrIdx="0"/>
  <p:cmAuthor id="1" name="Flohé Stefanie" initials="FS" lastIdx="14" clrIdx="1"/>
  <p:cmAuthor id="2" name="St.Flohe" initials="S" lastIdx="10" clrIdx="2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6600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Objects="1">
      <p:cViewPr>
        <p:scale>
          <a:sx n="125" d="100"/>
          <a:sy n="125" d="100"/>
        </p:scale>
        <p:origin x="-2268" y="-4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10" cy="7201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12B25-288B-47C1-95C5-163CD305E1FB}" type="datetimeFigureOut">
              <a:rPr lang="de-DE" smtClean="0"/>
              <a:t>17.03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CB7A61-6075-48CE-BEB8-1369E99CC12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365073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12B25-288B-47C1-95C5-163CD305E1FB}" type="datetimeFigureOut">
              <a:rPr lang="de-DE" smtClean="0"/>
              <a:t>17.03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CB7A61-6075-48CE-BEB8-1369E99CC12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250011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12B25-288B-47C1-95C5-163CD305E1FB}" type="datetimeFigureOut">
              <a:rPr lang="de-DE" smtClean="0"/>
              <a:t>17.03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CB7A61-6075-48CE-BEB8-1369E99CC12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258497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12B25-288B-47C1-95C5-163CD305E1FB}" type="datetimeFigureOut">
              <a:rPr lang="de-DE" smtClean="0"/>
              <a:t>17.03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CB7A61-6075-48CE-BEB8-1369E99CC12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435639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12B25-288B-47C1-95C5-163CD305E1FB}" type="datetimeFigureOut">
              <a:rPr lang="de-DE" smtClean="0"/>
              <a:t>17.03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CB7A61-6075-48CE-BEB8-1369E99CC12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574368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12B25-288B-47C1-95C5-163CD305E1FB}" type="datetimeFigureOut">
              <a:rPr lang="de-DE" smtClean="0"/>
              <a:t>17.03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CB7A61-6075-48CE-BEB8-1369E99CC12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252566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12B25-288B-47C1-95C5-163CD305E1FB}" type="datetimeFigureOut">
              <a:rPr lang="de-DE" smtClean="0"/>
              <a:t>17.03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CB7A61-6075-48CE-BEB8-1369E99CC12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594315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12B25-288B-47C1-95C5-163CD305E1FB}" type="datetimeFigureOut">
              <a:rPr lang="de-DE" smtClean="0"/>
              <a:t>17.03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CB7A61-6075-48CE-BEB8-1369E99CC12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032878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12B25-288B-47C1-95C5-163CD305E1FB}" type="datetimeFigureOut">
              <a:rPr lang="de-DE" smtClean="0"/>
              <a:t>17.03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CB7A61-6075-48CE-BEB8-1369E99CC12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817677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12B25-288B-47C1-95C5-163CD305E1FB}" type="datetimeFigureOut">
              <a:rPr lang="de-DE" smtClean="0"/>
              <a:t>17.03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CB7A61-6075-48CE-BEB8-1369E99CC12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13007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12B25-288B-47C1-95C5-163CD305E1FB}" type="datetimeFigureOut">
              <a:rPr lang="de-DE" smtClean="0"/>
              <a:t>17.03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CB7A61-6075-48CE-BEB8-1369E99CC12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469727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E12B25-288B-47C1-95C5-163CD305E1FB}" type="datetimeFigureOut">
              <a:rPr lang="de-DE" smtClean="0"/>
              <a:t>17.03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CB7A61-6075-48CE-BEB8-1369E99CC12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082516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emf"/><Relationship Id="rId3" Type="http://schemas.openxmlformats.org/officeDocument/2006/relationships/image" Target="../media/image3.emf"/><Relationship Id="rId7" Type="http://schemas.openxmlformats.org/officeDocument/2006/relationships/oleObject" Target="../embeddings/oleObject2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.emf"/><Relationship Id="rId5" Type="http://schemas.openxmlformats.org/officeDocument/2006/relationships/oleObject" Target="../embeddings/oleObject1.bin"/><Relationship Id="rId4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/>
          <p:cNvSpPr txBox="1"/>
          <p:nvPr/>
        </p:nvSpPr>
        <p:spPr>
          <a:xfrm>
            <a:off x="3421766" y="1020672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673719" y="4088880"/>
            <a:ext cx="513968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1.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Expression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L-15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ceptor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(CD122)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smtClean="0">
                <a:latin typeface="Symbol" panose="05050102010706020507" pitchFamily="18" charset="2"/>
                <a:cs typeface="Arial" panose="020B0604020202020204" pitchFamily="34" charset="0"/>
              </a:rPr>
              <a:t>g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CD132)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hain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on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D56</a:t>
            </a:r>
            <a:r>
              <a:rPr lang="de-DE" sz="10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bright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NK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BMC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ealthy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ntrol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(c)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auma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(t)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tained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CD122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CD132 </a:t>
            </a:r>
            <a:r>
              <a:rPr lang="de-DE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ex vivo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)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presentative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istogram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B, C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umulative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ercentage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CD56</a:t>
            </a:r>
            <a:r>
              <a:rPr lang="de-DE" sz="10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bright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NK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positive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CD122 (B; n=13)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CD132 (C; n=14). Horizontal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line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dicate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median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terquartile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ange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so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isotype control.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393" name="Picture 9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66577" y="2576890"/>
            <a:ext cx="1068429" cy="10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6392" name="Picture 8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66577" y="1381244"/>
            <a:ext cx="1068429" cy="10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feld 4"/>
          <p:cNvSpPr txBox="1"/>
          <p:nvPr/>
        </p:nvSpPr>
        <p:spPr>
          <a:xfrm>
            <a:off x="1203191" y="1020672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9" name="Objek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33969399"/>
              </p:ext>
            </p:extLst>
          </p:nvPr>
        </p:nvGraphicFramePr>
        <p:xfrm>
          <a:off x="3565702" y="2663202"/>
          <a:ext cx="1461163" cy="14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466" name="Prism Project" r:id="rId5" imgW="2412000" imgH="2376000" progId="Prism5.Document">
                  <p:embed/>
                </p:oleObj>
              </mc:Choice>
              <mc:Fallback>
                <p:oleObj name="Prism Project" r:id="rId5" imgW="2412000" imgH="2376000" progId="Prism5.Document">
                  <p:embed/>
                  <p:pic>
                    <p:nvPicPr>
                      <p:cNvPr id="0" name="Objekt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565702" y="2663202"/>
                        <a:ext cx="1461163" cy="144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k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71675003"/>
              </p:ext>
            </p:extLst>
          </p:nvPr>
        </p:nvGraphicFramePr>
        <p:xfrm>
          <a:off x="3542798" y="1098868"/>
          <a:ext cx="1483287" cy="14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467" name="Prism Project" r:id="rId7" imgW="2448000" imgH="2376000" progId="Prism5.Document">
                  <p:embed/>
                </p:oleObj>
              </mc:Choice>
              <mc:Fallback>
                <p:oleObj name="Prism Project" r:id="rId7" imgW="2448000" imgH="2376000" progId="Prism5.Document">
                  <p:embed/>
                  <p:pic>
                    <p:nvPicPr>
                      <p:cNvPr id="0" name="Objek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542798" y="1098868"/>
                        <a:ext cx="1483287" cy="144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" name="Textfeld 15"/>
          <p:cNvSpPr txBox="1"/>
          <p:nvPr/>
        </p:nvSpPr>
        <p:spPr>
          <a:xfrm>
            <a:off x="3421766" y="252470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1707171" y="2415257"/>
            <a:ext cx="7864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D122</a:t>
            </a:r>
          </a:p>
        </p:txBody>
      </p:sp>
      <p:sp>
        <p:nvSpPr>
          <p:cNvPr id="26" name="Textfeld 25"/>
          <p:cNvSpPr txBox="1"/>
          <p:nvPr/>
        </p:nvSpPr>
        <p:spPr>
          <a:xfrm>
            <a:off x="1704290" y="3599718"/>
            <a:ext cx="7864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D132</a:t>
            </a:r>
          </a:p>
        </p:txBody>
      </p:sp>
      <p:sp>
        <p:nvSpPr>
          <p:cNvPr id="29" name="Textfeld 28"/>
          <p:cNvSpPr txBox="1"/>
          <p:nvPr/>
        </p:nvSpPr>
        <p:spPr>
          <a:xfrm rot="16200000">
            <a:off x="961031" y="2401003"/>
            <a:ext cx="8436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unt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Gerade Verbindung 29"/>
          <p:cNvCxnSpPr/>
          <p:nvPr/>
        </p:nvCxnSpPr>
        <p:spPr>
          <a:xfrm>
            <a:off x="1485062" y="1438832"/>
            <a:ext cx="0" cy="2156236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Textfeld 20"/>
          <p:cNvSpPr txBox="1"/>
          <p:nvPr/>
        </p:nvSpPr>
        <p:spPr>
          <a:xfrm>
            <a:off x="2827129" y="2416981"/>
            <a:ext cx="4940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feld 21"/>
          <p:cNvSpPr txBox="1"/>
          <p:nvPr/>
        </p:nvSpPr>
        <p:spPr>
          <a:xfrm>
            <a:off x="2827129" y="2287831"/>
            <a:ext cx="4320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so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feld 22"/>
          <p:cNvSpPr txBox="1"/>
          <p:nvPr/>
        </p:nvSpPr>
        <p:spPr>
          <a:xfrm>
            <a:off x="2827129" y="2555488"/>
            <a:ext cx="5052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auma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Gerade Verbindung 23"/>
          <p:cNvCxnSpPr/>
          <p:nvPr/>
        </p:nvCxnSpPr>
        <p:spPr>
          <a:xfrm>
            <a:off x="2710458" y="2400894"/>
            <a:ext cx="14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Gerade Verbindung 24"/>
          <p:cNvCxnSpPr/>
          <p:nvPr/>
        </p:nvCxnSpPr>
        <p:spPr>
          <a:xfrm>
            <a:off x="2710458" y="2538544"/>
            <a:ext cx="144000" cy="0"/>
          </a:xfrm>
          <a:prstGeom prst="line">
            <a:avLst/>
          </a:prstGeom>
          <a:ln>
            <a:solidFill>
              <a:schemeClr val="tx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Gerade Verbindung 26"/>
          <p:cNvCxnSpPr/>
          <p:nvPr/>
        </p:nvCxnSpPr>
        <p:spPr>
          <a:xfrm>
            <a:off x="2710458" y="2663210"/>
            <a:ext cx="144000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400500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9</Words>
  <Application>Microsoft Office PowerPoint</Application>
  <PresentationFormat>A4-Papier (210x297 mm)</PresentationFormat>
  <Paragraphs>10</Paragraphs>
  <Slides>1</Slides>
  <Notes>0</Notes>
  <HiddenSlides>0</HiddenSlides>
  <MMClips>0</MMClips>
  <ScaleCrop>false</ScaleCrop>
  <HeadingPairs>
    <vt:vector size="6" baseType="variant"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3" baseType="lpstr">
      <vt:lpstr>Larissa</vt:lpstr>
      <vt:lpstr>GraphPad Prism 5 Project</vt:lpstr>
      <vt:lpstr>PowerPoint-Präsentation</vt:lpstr>
    </vt:vector>
  </TitlesOfParts>
  <Company>Universitätsklinikum Esse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Flohé Stefanie</dc:creator>
  <cp:lastModifiedBy>Flohé Stefanie</cp:lastModifiedBy>
  <cp:revision>208</cp:revision>
  <cp:lastPrinted>2020-03-03T13:56:16Z</cp:lastPrinted>
  <dcterms:created xsi:type="dcterms:W3CDTF">2020-02-18T09:22:44Z</dcterms:created>
  <dcterms:modified xsi:type="dcterms:W3CDTF">2020-03-17T11:45:15Z</dcterms:modified>
</cp:coreProperties>
</file>